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openxmlformats.org/officeDocument/2006/relationships/custom-properties" Target="docProps/custom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33A56B-E900-4531-AEDE-D9C6929E8124}" v="1" dt="2025-03-12T12:09:38.68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324" y="-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openxmlformats.org/officeDocument/2006/relationships/customXml" Target="../customXml/item3.xml"/><Relationship Id="rId5" Type="http://schemas.openxmlformats.org/officeDocument/2006/relationships/theme" Target="theme/theme1.xml"/><Relationship Id="rId10" Type="http://schemas.openxmlformats.org/officeDocument/2006/relationships/customXml" Target="../customXml/item2.xml"/><Relationship Id="rId4" Type="http://schemas.openxmlformats.org/officeDocument/2006/relationships/viewProps" Target="viewProps.xml"/><Relationship Id="rId9" Type="http://schemas.openxmlformats.org/officeDocument/2006/relationships/customXml" Target="../customXml/item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tler, Rachel Dr (Sch of Biosciences)" userId="6a2ec099-ba7b-4cf6-80c6-d6c39faa2e11" providerId="ADAL" clId="{6533A56B-E900-4531-AEDE-D9C6929E8124}"/>
    <pc:docChg chg="custSel modSld">
      <pc:chgData name="Butler, Rachel Dr (Sch of Biosciences)" userId="6a2ec099-ba7b-4cf6-80c6-d6c39faa2e11" providerId="ADAL" clId="{6533A56B-E900-4531-AEDE-D9C6929E8124}" dt="2025-03-12T12:11:45.893" v="112" actId="14100"/>
      <pc:docMkLst>
        <pc:docMk/>
      </pc:docMkLst>
      <pc:sldChg chg="addSp delSp modSp mod">
        <pc:chgData name="Butler, Rachel Dr (Sch of Biosciences)" userId="6a2ec099-ba7b-4cf6-80c6-d6c39faa2e11" providerId="ADAL" clId="{6533A56B-E900-4531-AEDE-D9C6929E8124}" dt="2025-03-12T12:11:45.893" v="112" actId="14100"/>
        <pc:sldMkLst>
          <pc:docMk/>
          <pc:sldMk cId="2936261433" sldId="256"/>
        </pc:sldMkLst>
        <pc:spChg chg="mod">
          <ac:chgData name="Butler, Rachel Dr (Sch of Biosciences)" userId="6a2ec099-ba7b-4cf6-80c6-d6c39faa2e11" providerId="ADAL" clId="{6533A56B-E900-4531-AEDE-D9C6929E8124}" dt="2025-03-12T12:11:45.893" v="112" actId="14100"/>
          <ac:spMkLst>
            <pc:docMk/>
            <pc:sldMk cId="2936261433" sldId="256"/>
            <ac:spMk id="7" creationId="{1F401185-7F2F-81BD-4938-6650CBAC0ABC}"/>
          </ac:spMkLst>
        </pc:spChg>
        <pc:spChg chg="mod">
          <ac:chgData name="Butler, Rachel Dr (Sch of Biosciences)" userId="6a2ec099-ba7b-4cf6-80c6-d6c39faa2e11" providerId="ADAL" clId="{6533A56B-E900-4531-AEDE-D9C6929E8124}" dt="2025-03-12T12:10:23.299" v="12" actId="20577"/>
          <ac:spMkLst>
            <pc:docMk/>
            <pc:sldMk cId="2936261433" sldId="256"/>
            <ac:spMk id="8" creationId="{4FA2F565-44E5-C48D-33A3-3B072007EE18}"/>
          </ac:spMkLst>
        </pc:spChg>
        <pc:spChg chg="mod">
          <ac:chgData name="Butler, Rachel Dr (Sch of Biosciences)" userId="6a2ec099-ba7b-4cf6-80c6-d6c39faa2e11" providerId="ADAL" clId="{6533A56B-E900-4531-AEDE-D9C6929E8124}" dt="2025-03-12T12:11:22.198" v="110" actId="20577"/>
          <ac:spMkLst>
            <pc:docMk/>
            <pc:sldMk cId="2936261433" sldId="256"/>
            <ac:spMk id="9" creationId="{843A6A94-3504-BAF3-22C9-8A41D2FE9BFD}"/>
          </ac:spMkLst>
        </pc:spChg>
        <pc:picChg chg="add mod ord">
          <ac:chgData name="Butler, Rachel Dr (Sch of Biosciences)" userId="6a2ec099-ba7b-4cf6-80c6-d6c39faa2e11" providerId="ADAL" clId="{6533A56B-E900-4531-AEDE-D9C6929E8124}" dt="2025-03-12T12:09:53.980" v="5" actId="1076"/>
          <ac:picMkLst>
            <pc:docMk/>
            <pc:sldMk cId="2936261433" sldId="256"/>
            <ac:picMk id="3" creationId="{2AC0B3C7-0440-14DB-32AF-F3493122C478}"/>
          </ac:picMkLst>
        </pc:picChg>
        <pc:picChg chg="del">
          <ac:chgData name="Butler, Rachel Dr (Sch of Biosciences)" userId="6a2ec099-ba7b-4cf6-80c6-d6c39faa2e11" providerId="ADAL" clId="{6533A56B-E900-4531-AEDE-D9C6929E8124}" dt="2025-03-12T12:09:31.398" v="0" actId="478"/>
          <ac:picMkLst>
            <pc:docMk/>
            <pc:sldMk cId="2936261433" sldId="256"/>
            <ac:picMk id="5" creationId="{2B04B3C7-5BA6-2E7F-3811-E0A038DEECC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51B04-B2B9-D5B3-B443-8EFEB37D15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AAEA72-D2CE-6559-326B-457B66C1D7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BF947-A4AB-D113-C6DD-EED299EB1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53194-E48B-6802-991B-C3C2E2A31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8203B0-676D-55FD-9EB9-CCE23685A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691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68904-A0EA-6D48-096B-D7E3DEEBC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B7ACEA-996D-8498-70AE-8091E7A724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D49FCF-019E-002D-0E5B-B724BABE9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C3E908-F575-0D5F-57FE-D22B9FFBF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D35AD5-8D1F-9715-9002-91359D57D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348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657A2F-DE36-1E64-8890-3137D0A170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553AE1-E512-F9C1-E3FA-977C69F5E5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73FDD-0D11-BF78-A571-D6DA7D7C4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BB7C1F-D18D-7792-9DBF-62BF683D4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2E60E-7B14-3F85-5166-10BE0DF5B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548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8B5A7-FDFE-1FAE-F542-D967EF085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F65E1-B6C4-A122-A050-C68D4EA06D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A6A61F-EC9C-0AC4-A8D9-091B966D6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2C076-A62D-6E0B-A52C-2B739343A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FFEF6-0483-8087-973C-5F04590A9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905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B6A2A-1D26-D747-65D3-B9D0946FCE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77A967-F3C6-3E61-5B67-D0E52046D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17FB4-19E3-F08F-F99A-68706511A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D1FA72-4784-5685-A4E4-9279E35AE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613101-6778-C98E-B0E1-724898B07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2142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5936E-8E9B-3C7A-D763-89778FE3B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E75FA0-CCF6-CC9C-AFE4-B019C8AF0B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07AC83-0128-DEA4-1C9B-36307A1952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474C7E-568D-1FD9-8D02-7BD5480D8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9B87DD-F1C2-2F8D-5EB6-A55BA1918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B54A4E-C3D2-0318-9FB9-256621A56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4379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F6152-7B58-D98D-95A0-4C06166DB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CBA667-B6CF-3D0F-77B7-4CA3CED8D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80AD42-9410-282B-6E42-D8A91B9332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07EACA-8BF9-3242-4534-DC15E58CFB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5FD267-9A2F-F179-C09E-84A14896AC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AE301E-A2CC-8402-1867-0774CDB9D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71BFDC-3C30-CE7F-1446-918439E45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0B14F9-62E0-9A05-6CE2-FAE7CE4CA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61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F097B-A3E2-C3A8-0D4F-B0DF0EC59C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7FD25E-47D8-82CF-F466-12ADBAA63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B8BA2F-59E2-F5ED-7BD7-D4B266EBD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BB6A34-5ACD-89C7-0743-495D41D7E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9866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85B0FC-20DD-9011-BE17-BB8D58BC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50A89B-5B27-0F16-D54D-555E3C7CD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FD55D1-1984-86A3-C005-C6571BE69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14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2D2AE-F2E4-3118-3B77-B57606263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5976DA-1E95-F045-BD89-E55073447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0FD1B5-6D20-EE5F-B00E-495EAD17C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C04722-79EE-3D8B-58C5-185072C36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43CA07-2DC6-61CC-C0D3-150996CC3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9B6F23-663D-C386-CE51-FE6779018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409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4A6919-A560-52ED-DC3E-F96F4B04C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6CF39F-52C5-3745-4428-EC2A1E730F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AB4E51-E0C1-9730-1EAE-CF139AF20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764BC1-D0A9-128E-C6A2-4957838D0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155F9D-DF76-1864-567F-4C1CB12C9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C9E068-6BD7-C669-559D-04F56DDDD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727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120697-4BF3-525E-C6A2-C90EEED89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C328A2-5031-7DAF-4632-30EC89CFC9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02695-7671-C0F2-C0CC-14602E255D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69ADC9-10BF-034A-6156-505EA0FFE7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E4A1DE-547D-4675-BB5B-23553B11E0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92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transparent object with light coming out of it&#10;&#10;AI-generated content may be incorrect.">
            <a:extLst>
              <a:ext uri="{FF2B5EF4-FFF2-40B4-BE49-F238E27FC236}">
                <a16:creationId xmlns:a16="http://schemas.microsoft.com/office/drawing/2014/main" id="{2AC0B3C7-0440-14DB-32AF-F3493122C4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30" y="600740"/>
            <a:ext cx="6400800" cy="4572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F401185-7F2F-81BD-4938-6650CBAC0ABC}"/>
              </a:ext>
            </a:extLst>
          </p:cNvPr>
          <p:cNvSpPr/>
          <p:nvPr/>
        </p:nvSpPr>
        <p:spPr>
          <a:xfrm>
            <a:off x="1861204" y="2007528"/>
            <a:ext cx="2273916" cy="1681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A2F565-44E5-C48D-33A3-3B072007EE18}"/>
              </a:ext>
            </a:extLst>
          </p:cNvPr>
          <p:cNvSpPr txBox="1"/>
          <p:nvPr/>
        </p:nvSpPr>
        <p:spPr>
          <a:xfrm>
            <a:off x="1827123" y="743680"/>
            <a:ext cx="2225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1   2   3  4  5   6  7   8  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3A6A94-3504-BAF3-22C9-8A41D2FE9BFD}"/>
              </a:ext>
            </a:extLst>
          </p:cNvPr>
          <p:cNvSpPr txBox="1"/>
          <p:nvPr/>
        </p:nvSpPr>
        <p:spPr>
          <a:xfrm>
            <a:off x="6880994" y="1113012"/>
            <a:ext cx="5381538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 100bp ladder</a:t>
            </a:r>
          </a:p>
          <a:p>
            <a:endParaRPr lang="en-GB" dirty="0"/>
          </a:p>
          <a:p>
            <a:r>
              <a:rPr lang="en-GB" dirty="0"/>
              <a:t>2 Rv2059, unmodified</a:t>
            </a:r>
          </a:p>
          <a:p>
            <a:r>
              <a:rPr lang="en-GB" dirty="0"/>
              <a:t>3 Rv2059, unmodified + Zur protein</a:t>
            </a:r>
          </a:p>
          <a:p>
            <a:endParaRPr lang="en-GB" dirty="0"/>
          </a:p>
          <a:p>
            <a:r>
              <a:rPr lang="en-GB" dirty="0"/>
              <a:t>4 Rv2059, upper strand </a:t>
            </a:r>
            <a:r>
              <a:rPr lang="en-GB" dirty="0" err="1"/>
              <a:t>ADPr</a:t>
            </a:r>
            <a:r>
              <a:rPr lang="en-GB" dirty="0"/>
              <a:t> </a:t>
            </a:r>
          </a:p>
          <a:p>
            <a:r>
              <a:rPr lang="en-GB" dirty="0"/>
              <a:t>5 Rv2059, upper strand </a:t>
            </a:r>
            <a:r>
              <a:rPr lang="en-GB" dirty="0" err="1"/>
              <a:t>ADPr</a:t>
            </a:r>
            <a:r>
              <a:rPr lang="en-GB" dirty="0"/>
              <a:t> + Zur protein</a:t>
            </a:r>
          </a:p>
          <a:p>
            <a:endParaRPr lang="en-GB" dirty="0"/>
          </a:p>
          <a:p>
            <a:r>
              <a:rPr lang="en-GB" dirty="0"/>
              <a:t>6 Rv2059, lower strand </a:t>
            </a:r>
            <a:r>
              <a:rPr lang="en-GB" dirty="0" err="1"/>
              <a:t>ADPr</a:t>
            </a:r>
            <a:r>
              <a:rPr lang="en-GB" dirty="0"/>
              <a:t> </a:t>
            </a:r>
          </a:p>
          <a:p>
            <a:r>
              <a:rPr lang="en-GB" dirty="0"/>
              <a:t>7 Rv2059, lower strand </a:t>
            </a:r>
            <a:r>
              <a:rPr lang="en-GB" dirty="0" err="1"/>
              <a:t>ADPr</a:t>
            </a:r>
            <a:r>
              <a:rPr lang="en-GB" dirty="0"/>
              <a:t> + Zur protein</a:t>
            </a:r>
          </a:p>
          <a:p>
            <a:endParaRPr lang="en-GB" dirty="0"/>
          </a:p>
          <a:p>
            <a:r>
              <a:rPr lang="en-GB" dirty="0"/>
              <a:t>8 Rv2059, upper and lower strand </a:t>
            </a:r>
            <a:r>
              <a:rPr lang="en-GB" dirty="0" err="1"/>
              <a:t>ADPr</a:t>
            </a:r>
            <a:endParaRPr lang="en-GB" dirty="0"/>
          </a:p>
          <a:p>
            <a:r>
              <a:rPr lang="en-GB" dirty="0"/>
              <a:t>9 Rv2059, upper and lower strand </a:t>
            </a:r>
            <a:r>
              <a:rPr lang="en-GB" dirty="0" err="1"/>
              <a:t>ADPr</a:t>
            </a:r>
            <a:r>
              <a:rPr lang="en-GB" dirty="0"/>
              <a:t> + Zur protein 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36261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98730C5DFCF246B154C9145A71693D" ma:contentTypeVersion="12" ma:contentTypeDescription="Create a new document." ma:contentTypeScope="" ma:versionID="ae7b9c86051f4e040dac568b69fb0128">
  <xsd:schema xmlns:xsd="http://www.w3.org/2001/XMLSchema" xmlns:xs="http://www.w3.org/2001/XMLSchema" xmlns:p="http://schemas.microsoft.com/office/2006/metadata/properties" xmlns:ns2="3d001f60-a2d7-4d7d-b13f-e8538330c949" xmlns:ns3="33967b2d-0c2e-4b90-8b20-39fe1832c3e1" targetNamespace="http://schemas.microsoft.com/office/2006/metadata/properties" ma:root="true" ma:fieldsID="757bba51fdd94759903aa6d2e9861751" ns2:_="" ns3:_="">
    <xsd:import namespace="3d001f60-a2d7-4d7d-b13f-e8538330c949"/>
    <xsd:import namespace="33967b2d-0c2e-4b90-8b20-39fe1832c3e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01f60-a2d7-4d7d-b13f-e8538330c9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58692e38-9dd4-4db7-af25-16fcd4767bb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967b2d-0c2e-4b90-8b20-39fe1832c3e1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5c77dd19-a496-43b3-950e-f870f8ef18e7}" ma:internalName="TaxCatchAll" ma:showField="CatchAllData" ma:web="33967b2d-0c2e-4b90-8b20-39fe1832c3e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d001f60-a2d7-4d7d-b13f-e8538330c949">
      <Terms xmlns="http://schemas.microsoft.com/office/infopath/2007/PartnerControls"/>
    </lcf76f155ced4ddcb4097134ff3c332f>
    <TaxCatchAll xmlns="33967b2d-0c2e-4b90-8b20-39fe1832c3e1" xsi:nil="true"/>
  </documentManagement>
</p:properties>
</file>

<file path=customXml/itemProps1.xml><?xml version="1.0" encoding="utf-8"?>
<ds:datastoreItem xmlns:ds="http://schemas.openxmlformats.org/officeDocument/2006/customXml" ds:itemID="{9CA7611E-EF1B-4FFF-88BC-168DF1853F60}"/>
</file>

<file path=customXml/itemProps2.xml><?xml version="1.0" encoding="utf-8"?>
<ds:datastoreItem xmlns:ds="http://schemas.openxmlformats.org/officeDocument/2006/customXml" ds:itemID="{037E4E07-3F5F-44B1-A9A4-AAA41345CA2D}"/>
</file>

<file path=customXml/itemProps3.xml><?xml version="1.0" encoding="utf-8"?>
<ds:datastoreItem xmlns:ds="http://schemas.openxmlformats.org/officeDocument/2006/customXml" ds:itemID="{E278911D-C966-4CF9-A570-7D0C70C7C20C}"/>
</file>

<file path=docMetadata/LabelInfo.xml><?xml version="1.0" encoding="utf-8"?>
<clbl:labelList xmlns:clbl="http://schemas.microsoft.com/office/2020/mipLabelMetadata">
  <clbl:label id="{6b902693-1074-40aa-9e21-d89446a2ebb5}" enabled="0" method="" siteId="{6b902693-1074-40aa-9e21-d89446a2ebb5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2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tler, Rachel Dr (Sch of Biosciences)</dc:creator>
  <cp:lastModifiedBy>Butler, Rachel Dr (Sch of Biosciences)</cp:lastModifiedBy>
  <cp:revision>2</cp:revision>
  <dcterms:created xsi:type="dcterms:W3CDTF">2025-03-12T11:59:54Z</dcterms:created>
  <dcterms:modified xsi:type="dcterms:W3CDTF">2025-03-12T12:11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98730C5DFCF246B154C9145A71693D</vt:lpwstr>
  </property>
</Properties>
</file>